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262" r:id="rId2"/>
    <p:sldId id="263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upplementary" id="{49E882F5-072D-DF4F-92E7-EF0AD4F7E177}">
          <p14:sldIdLst>
            <p14:sldId id="262"/>
            <p14:sldId id="263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1168B"/>
    <a:srgbClr val="FF24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969"/>
    <p:restoredTop sz="97674"/>
  </p:normalViewPr>
  <p:slideViewPr>
    <p:cSldViewPr snapToGrid="0">
      <p:cViewPr>
        <p:scale>
          <a:sx n="86" d="100"/>
          <a:sy n="86" d="100"/>
        </p:scale>
        <p:origin x="326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6E5109-D852-D04E-B9E8-0C8B47B42F75}" type="datetimeFigureOut">
              <a:rPr lang="en-US" smtClean="0"/>
              <a:t>6/17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460014-EC34-1548-9FB8-4F8B94B69A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4375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6460014-EC34-1548-9FB8-4F8B94B69AE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12408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3810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9836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8620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30670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9231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483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9252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2528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10957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8443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8542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076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2D5F183F-2518-DB2B-2B72-901DE28EECAC}"/>
              </a:ext>
            </a:extLst>
          </p:cNvPr>
          <p:cNvSpPr txBox="1"/>
          <p:nvPr/>
        </p:nvSpPr>
        <p:spPr>
          <a:xfrm>
            <a:off x="0" y="0"/>
            <a:ext cx="2267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S7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09DA3B2-84D4-B4E2-F9A4-46024F8C2838}"/>
              </a:ext>
            </a:extLst>
          </p:cNvPr>
          <p:cNvSpPr txBox="1"/>
          <p:nvPr/>
        </p:nvSpPr>
        <p:spPr>
          <a:xfrm>
            <a:off x="-19883" y="28340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2D0D143-29CE-527B-475B-344D208E2D1C}"/>
              </a:ext>
            </a:extLst>
          </p:cNvPr>
          <p:cNvSpPr txBox="1"/>
          <p:nvPr/>
        </p:nvSpPr>
        <p:spPr>
          <a:xfrm>
            <a:off x="-19883" y="197853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66A46D3-D713-B907-99E1-D97ED996DC45}"/>
              </a:ext>
            </a:extLst>
          </p:cNvPr>
          <p:cNvSpPr txBox="1"/>
          <p:nvPr/>
        </p:nvSpPr>
        <p:spPr>
          <a:xfrm>
            <a:off x="3519427" y="1975938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4243C75-BCDC-2F9C-A7DA-6D498967E368}"/>
              </a:ext>
            </a:extLst>
          </p:cNvPr>
          <p:cNvSpPr txBox="1"/>
          <p:nvPr/>
        </p:nvSpPr>
        <p:spPr>
          <a:xfrm>
            <a:off x="-19883" y="5005571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E9ADA5C9-0C9A-F466-781E-D96973FB8D2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-76"/>
          <a:stretch/>
        </p:blipFill>
        <p:spPr>
          <a:xfrm>
            <a:off x="268313" y="5190237"/>
            <a:ext cx="4046826" cy="1359238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B26A036F-34F6-3B3E-9F93-8384DB5016B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55467" y="565139"/>
            <a:ext cx="2845045" cy="1325332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E72C8FEF-C9BE-AF58-5657-A8B4ED4E6F1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8313" y="2347870"/>
            <a:ext cx="2782914" cy="2662912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A82D2FBF-BC79-CF99-0B0B-FAE175636BE1}"/>
              </a:ext>
            </a:extLst>
          </p:cNvPr>
          <p:cNvSpPr txBox="1"/>
          <p:nvPr/>
        </p:nvSpPr>
        <p:spPr>
          <a:xfrm>
            <a:off x="-19883" y="6625169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04D3279-A1AF-CA62-FDBB-39FE1B9027B8}"/>
              </a:ext>
            </a:extLst>
          </p:cNvPr>
          <p:cNvSpPr txBox="1"/>
          <p:nvPr/>
        </p:nvSpPr>
        <p:spPr>
          <a:xfrm>
            <a:off x="3519427" y="6622646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293B5BC1-A757-8182-EA8A-62DB735ACF2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27525" y="2168001"/>
            <a:ext cx="2779952" cy="2825807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960DF64C-8D7F-FE7D-26CE-1DF9A83AADB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0" y="7049276"/>
            <a:ext cx="3275937" cy="2806947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8BE0740-C546-07A0-FCCB-A3D79E47947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519427" y="7138878"/>
            <a:ext cx="3275937" cy="27671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649329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3055443-AB7B-2D36-77F1-924C4791F35B}"/>
              </a:ext>
            </a:extLst>
          </p:cNvPr>
          <p:cNvSpPr txBox="1"/>
          <p:nvPr/>
        </p:nvSpPr>
        <p:spPr>
          <a:xfrm>
            <a:off x="100013" y="185737"/>
            <a:ext cx="6572250" cy="36009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spcBef>
                <a:spcPts val="300"/>
              </a:spcBef>
            </a:pPr>
            <a:r>
              <a:rPr lang="en-US" sz="8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upplementary Figure 7. Immunophenotyping data of REP TIL and tumor co-culture assays</a:t>
            </a:r>
            <a:endParaRPr lang="en-US" sz="800" dirty="0">
              <a:effectLst/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342900" lvl="0" indent="-342900">
              <a:spcBef>
                <a:spcPts val="300"/>
              </a:spcBef>
              <a:buFont typeface="+mj-lt"/>
              <a:buAutoNum type="alphaUcPeriod"/>
            </a:pP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IFN-</a:t>
            </a:r>
            <a:r>
              <a:rPr lang="en-US" sz="800" dirty="0">
                <a:effectLst/>
                <a:latin typeface="Calibri" panose="020F0502020204030204" pitchFamily="34" charset="0"/>
                <a:ea typeface="Malgun Gothic" panose="020B0503020000020004" pitchFamily="34" charset="-127"/>
                <a:cs typeface="Times New Roman" panose="02020603050405020304" pitchFamily="18" charset="0"/>
                <a:sym typeface="Symbol" pitchFamily="2" charset="2"/>
              </a:rPr>
              <a:t></a:t>
            </a: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and TNF-</a:t>
            </a:r>
            <a:r>
              <a:rPr lang="en-US" sz="800" dirty="0">
                <a:effectLst/>
                <a:latin typeface="Calibri" panose="020F0502020204030204" pitchFamily="34" charset="0"/>
                <a:ea typeface="Malgun Gothic" panose="020B0503020000020004" pitchFamily="34" charset="-127"/>
                <a:cs typeface="Times New Roman" panose="02020603050405020304" pitchFamily="18" charset="0"/>
                <a:sym typeface="Symbol" pitchFamily="2" charset="2"/>
              </a:rPr>
              <a:t></a:t>
            </a: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expression in the REP TIL (BASELINE_6h) vs co-culture with 2D </a:t>
            </a:r>
            <a:r>
              <a:rPr lang="en-US" sz="800" i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in vitro</a:t>
            </a: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cultured tumor cells (CO-CULTURE_6h) of the same patient (n=10) for 6h showed no differences. Approximately half the samples show an increase, whereas the other half show a decrease in IFN-</a:t>
            </a:r>
            <a:r>
              <a:rPr lang="en-US" sz="800" dirty="0">
                <a:effectLst/>
                <a:latin typeface="Calibri" panose="020F0502020204030204" pitchFamily="34" charset="0"/>
                <a:ea typeface="Malgun Gothic" panose="020B0503020000020004" pitchFamily="34" charset="-127"/>
                <a:cs typeface="Times New Roman" panose="02020603050405020304" pitchFamily="18" charset="0"/>
                <a:sym typeface="Symbol" pitchFamily="2" charset="2"/>
              </a:rPr>
              <a:t></a:t>
            </a: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and TNF-</a:t>
            </a:r>
            <a:r>
              <a:rPr lang="en-US" sz="800" dirty="0">
                <a:effectLst/>
                <a:latin typeface="Calibri" panose="020F0502020204030204" pitchFamily="34" charset="0"/>
                <a:ea typeface="Malgun Gothic" panose="020B0503020000020004" pitchFamily="34" charset="-127"/>
                <a:cs typeface="Times New Roman" panose="02020603050405020304" pitchFamily="18" charset="0"/>
                <a:sym typeface="Symbol" pitchFamily="2" charset="2"/>
              </a:rPr>
              <a:t></a:t>
            </a: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expression.</a:t>
            </a:r>
            <a:endParaRPr lang="en-FI" sz="8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342900" lvl="0" indent="-342900">
              <a:spcBef>
                <a:spcPts val="300"/>
              </a:spcBef>
              <a:buFont typeface="+mj-lt"/>
              <a:buAutoNum type="alphaUcPeriod"/>
            </a:pP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he degranulation markers (CD107a and CD107b) and Granzyme B (</a:t>
            </a:r>
            <a:r>
              <a:rPr lang="en-US" sz="8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GzB</a:t>
            </a: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) expressions were observed for 6h between only REP TILs (BASELINE _6h) vs unstimulated, co-cultured REP TILs (CO-CULTURE_6h), showing no significant changes. 4/10 samples were excluded due to the lack of sample material (pt125, pt280, pt423, pt613). Further details on the availability of the samples and fold-change are found in Supplementary Table S3.</a:t>
            </a:r>
            <a:endParaRPr lang="en-FI" sz="8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342900" lvl="0" indent="-342900">
              <a:spcBef>
                <a:spcPts val="300"/>
              </a:spcBef>
              <a:buFont typeface="+mj-lt"/>
              <a:buAutoNum type="alphaUcPeriod"/>
            </a:pP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imilarly, no differences were observed in the degranulation markers and </a:t>
            </a:r>
            <a:r>
              <a:rPr lang="en-US" sz="8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GzB</a:t>
            </a: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during 48h co-cultures, except in a borderline decrease in CD8+ T-cell CD107a/b, comparing only the REP TILs (BASELINE_48h) vs unstimulated, co-cultured REP TILs (CO-CULTURE_48h). 3/10 samples were excluded due to the lack of sample material (pt125, pt280, pt423). Further details are found in Supplementary Table S3. </a:t>
            </a:r>
            <a:endParaRPr lang="en-FI" sz="8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342900" lvl="0" indent="-342900">
              <a:spcBef>
                <a:spcPts val="300"/>
              </a:spcBef>
              <a:buFont typeface="+mj-lt"/>
              <a:buAutoNum type="alphaUcPeriod"/>
            </a:pP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No differences were observed in the LAG-3 and PD-1 expressions in the 48h co-cultures involving only REP TILs (BASELINE _48h) vs unstimulated co-cultured REP TILs (CO-CULTURE_48h).</a:t>
            </a:r>
            <a:endParaRPr lang="en-FI" sz="8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342900" lvl="0" indent="-342900">
              <a:spcBef>
                <a:spcPts val="300"/>
              </a:spcBef>
              <a:buFont typeface="+mj-lt"/>
              <a:buAutoNum type="alphaUcPeriod"/>
            </a:pP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Like panel B, observations for the degranulation markers (CD107a and CD107b) and </a:t>
            </a:r>
            <a:r>
              <a:rPr lang="en-US" sz="8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GzB</a:t>
            </a: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expressions were observed for 6h between unstimulated, co-cultured REP TILs (CO-CULTURE _6h) vs T-cell stimulated, co-cultured REP TILs (TSTIM_6h). A moderate decrease in CD8+ T-cell </a:t>
            </a:r>
            <a:r>
              <a:rPr lang="en-US" sz="8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GzB</a:t>
            </a: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expression at 6h in the T-cell stimulated co-cultures. Although no differences were observed, there was an increased trend in CD3+ and CD8+ T-cells CD107a/b expression after 6h of T-cell stimulation, compared to unstimulated co-cultures. T-cells were stimulated with anti-CD3, anti-CD28 and anti-CD49d. 4/10 samples were excluded in measuring CD107a/b due to the lack of sample material (pt125, pt280, pt423, pt613). Further details are found in Supplementary Table S3.</a:t>
            </a:r>
            <a:endParaRPr lang="en-FI" sz="8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342900" lvl="0" indent="-342900">
              <a:spcBef>
                <a:spcPts val="300"/>
              </a:spcBef>
              <a:buFont typeface="+mj-lt"/>
              <a:buAutoNum type="alphaUcPeriod"/>
            </a:pP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Like panel C, observations for the degranulation markers (CD107a and CD107b) and </a:t>
            </a:r>
            <a:r>
              <a:rPr lang="en-US" sz="8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GzB</a:t>
            </a: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expressions were observed for 48h between unstimulated, co-cultured REP TILs (CO-CULTURE _48h) vs T-cell stimulated, co-cultured REP TILs (TSTIM_48h), showing no significant changes. However, an increased trend in CD8+ T-cell CD107a/b expression was observed at 48h of T-cell stimulation compared to unstimulated co-cultures. 3/10 samples were excluded in measuring CD107a/b due to the lack of sample material (pt125, pt280, pt423). Further details are found in Supplementary Table S3. </a:t>
            </a:r>
            <a:endParaRPr lang="en-FI" sz="8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457200">
              <a:spcBef>
                <a:spcPts val="300"/>
              </a:spcBef>
            </a:pP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 </a:t>
            </a:r>
            <a:endParaRPr lang="en-FI" sz="8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228600">
              <a:spcBef>
                <a:spcPts val="300"/>
              </a:spcBef>
            </a:pP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Non-parametric Wilcoxon matched-pairs signed rank test was used for all analyses. ns, not significant.</a:t>
            </a:r>
            <a:endParaRPr lang="en-FI" sz="8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47005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993</TotalTime>
  <Words>544</Words>
  <Application>Microsoft Macintosh PowerPoint</Application>
  <PresentationFormat>A4-paperi (210 x 297 mm)</PresentationFormat>
  <Paragraphs>17</Paragraphs>
  <Slides>2</Slides>
  <Notes>1</Notes>
  <HiddenSlides>0</HiddenSlides>
  <MMClips>0</MMClips>
  <ScaleCrop>false</ScaleCrop>
  <HeadingPairs>
    <vt:vector size="6" baseType="variant">
      <vt:variant>
        <vt:lpstr>Käytetyt fontit</vt:lpstr>
      </vt:variant>
      <vt:variant>
        <vt:i4>4</vt:i4>
      </vt:variant>
      <vt:variant>
        <vt:lpstr>Teema</vt:lpstr>
      </vt:variant>
      <vt:variant>
        <vt:i4>1</vt:i4>
      </vt:variant>
      <vt:variant>
        <vt:lpstr>Dian otsikot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-esitys</vt:lpstr>
      <vt:lpstr>PowerPoint-esity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e, Moon Hee</dc:creator>
  <cp:lastModifiedBy>Mustjoki, Satu M</cp:lastModifiedBy>
  <cp:revision>395</cp:revision>
  <dcterms:created xsi:type="dcterms:W3CDTF">2022-10-13T13:05:53Z</dcterms:created>
  <dcterms:modified xsi:type="dcterms:W3CDTF">2023-06-17T07:22:41Z</dcterms:modified>
</cp:coreProperties>
</file>